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9" r:id="rId3"/>
    <p:sldId id="260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8" d="100"/>
          <a:sy n="78" d="100"/>
        </p:scale>
        <p:origin x="168" y="72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24D4A7-51D2-4DD5-9FA6-8868E369D5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F5CB086-CC09-4EDB-B3A2-6126FBB772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E3D120-0FFA-4FD4-88DD-9D52D123C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3AA900-4EAD-430B-BD5A-8EC9B979D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3A66B3-6999-4806-BD1C-4E796A131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045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77BB0C-68D9-4257-A2FF-C7A66EA779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BEB9D11-D2C2-43C5-8E77-BB538D49B9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788EA9-2B75-43A0-AA48-0E42FC606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3A6C82-60F1-44C1-BD52-9A359B2BE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838857-3180-44BA-99A9-EFBF1BF91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48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06B4A2F-C385-4348-8593-922EE6E10A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43A0570-57E9-40AD-A73E-2E2EF748F6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B21E48-C144-496C-BBD9-A5C358539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51643B-BA00-4C6C-BE1C-5D45E454F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D584F2-C459-4F2C-8776-4D2320622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4711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0CD2A5-862D-4A46-88C7-8D01D9E67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2BD38C-4C70-408C-A16C-6EEAB11675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43B2C8-F52F-454A-9938-78AFAA31F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B97A8D-81EE-42C0-82A8-46D48EC25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390067-B13D-45BF-93F9-134E3AC0C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282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5DC277-6648-4AF3-9510-BAC718954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4BA6D7A-AF8C-444B-AF3A-8C16996D5B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E4CCA6-3DEC-4170-930D-DA7A0359D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06D6FF-CF1E-4F01-8ABD-D2DC3C753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903EF3-746E-4394-833C-686CEC4B9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1415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CA37E2-9E17-431D-9D8D-62092906C2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34CD05-3402-4AA1-B45A-79B2142C0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562FC4-91E5-40B3-9249-57A97CB8F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8CEAAAB-DBD7-443E-9854-521308044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8493E29-8C5D-47B8-8759-6CAFF69DF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F2C104-939B-4006-A853-35B246A4C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774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0D9A22-1B45-436D-8252-669BDC2F09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E5F213-5763-4899-BD5A-0CEE9C2051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A4C8607-16B6-422F-A97B-BBFF067596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C77FA1E-0E82-4E9E-AF1C-159B77B9B9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F206A5E-7DEF-4734-A015-B7CFBED76C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5CC2678-DCFE-4A35-AEEC-C1EBE4D03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634BC81-8FED-4E72-8035-13AA87441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1F66CDA-C308-41CF-94FC-C9CCB5230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442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A35BDC-C6AF-4466-A5D7-F28F95ED9A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D3A7B7-72C9-428D-A135-00CE0DD81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D9DAC09-8F40-4C05-B5BD-1932ECD57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2F5BEFB-05CB-44B3-AAA4-F2F2795C0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570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B205E19-0A0E-459A-8D90-0BABDDA0C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4E103AF-DEF2-4822-A385-05E061DED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762D311-BD48-4BF3-9C7D-DA2889C99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342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29380F-3836-4948-883D-A24518A0A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88BEC6-E8E4-49D1-BAA6-7FFB3847F5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5C759A-BCF4-4FE9-A400-FB3700236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D00B05-4387-49A4-B67C-A9D7C1867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92BFDA-1492-4780-AF25-6AC6D538D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3E8977-260F-4C62-A4F0-03F9C6A29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7849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75F951-9751-4B2B-BC75-1FCCF5579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BEC4916-8894-4278-8DF9-13D5F5FAFE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CD07F7-8F43-48A0-B051-9FE21E2DF6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32E66BA-055A-432D-AA7C-1632B1BE4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2528D0-9FA9-41A7-AB9D-2CA2D3B1D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8A022E-13D2-49C3-8CB2-2D65660C3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684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1949270-6B70-47FB-927E-E1F5F56DF1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5EB144-B67D-4B12-ADF3-DC3126599C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58C233-E91E-43E5-BFA3-BCB1ECDD97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569B7-A8CB-4483-B893-0261B667ABED}" type="datetimeFigureOut">
              <a:rPr lang="zh-CN" altLang="en-US" smtClean="0"/>
              <a:t>2023/11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31CE13-5F77-4BD8-81AF-E09BF2A91E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80195F-E0A8-45F4-A061-796CF524F1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5B42A-0010-46B1-B6D4-F179DE893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38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>
            <a:extLst>
              <a:ext uri="{FF2B5EF4-FFF2-40B4-BE49-F238E27FC236}">
                <a16:creationId xmlns:a16="http://schemas.microsoft.com/office/drawing/2014/main" id="{4143A147-EBA0-4A07-9294-AFC00767549C}"/>
              </a:ext>
            </a:extLst>
          </p:cNvPr>
          <p:cNvGrpSpPr/>
          <p:nvPr/>
        </p:nvGrpSpPr>
        <p:grpSpPr>
          <a:xfrm>
            <a:off x="316689" y="13322"/>
            <a:ext cx="8808962" cy="6528884"/>
            <a:chOff x="1165775" y="13322"/>
            <a:chExt cx="8808962" cy="6528884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D7BC797D-8831-4DAE-ADE0-476C18837A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0673" y="315794"/>
              <a:ext cx="3735847" cy="3113206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CA870B7-246E-4B6A-A632-9AD78BD552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5775" y="315794"/>
              <a:ext cx="3735847" cy="3113206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58D86AB4-57C3-422D-B0EE-17207375E18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5775" y="4138162"/>
              <a:ext cx="4042264" cy="2404044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74DB68F9-0DB2-4C25-8BDB-685C71C8E29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80737" y="4138162"/>
              <a:ext cx="4094000" cy="2404044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BFE1FB7-14C5-489A-8891-B71B3AF47509}"/>
                </a:ext>
              </a:extLst>
            </p:cNvPr>
            <p:cNvSpPr txBox="1"/>
            <p:nvPr/>
          </p:nvSpPr>
          <p:spPr>
            <a:xfrm>
              <a:off x="1673524" y="3768830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y powd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81272DB-2454-43DB-9EF5-514F57001816}"/>
                </a:ext>
              </a:extLst>
            </p:cNvPr>
            <p:cNvSpPr txBox="1"/>
            <p:nvPr/>
          </p:nvSpPr>
          <p:spPr>
            <a:xfrm>
              <a:off x="1673524" y="13322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y powd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EEAC1D0-12D9-45BB-8CCC-179BF5CEAF87}"/>
                </a:ext>
              </a:extLst>
            </p:cNvPr>
            <p:cNvSpPr txBox="1"/>
            <p:nvPr/>
          </p:nvSpPr>
          <p:spPr>
            <a:xfrm>
              <a:off x="6274485" y="13322"/>
              <a:ext cx="22454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-washed powd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F74037F-084E-4ED3-946E-E04B1B412FD5}"/>
                </a:ext>
              </a:extLst>
            </p:cNvPr>
            <p:cNvSpPr txBox="1"/>
            <p:nvPr/>
          </p:nvSpPr>
          <p:spPr>
            <a:xfrm>
              <a:off x="6236322" y="3768830"/>
              <a:ext cx="22454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-washed powd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5D81D5A-F8B9-43E3-A8CD-BD2B66074164}"/>
                </a:ext>
              </a:extLst>
            </p:cNvPr>
            <p:cNvSpPr txBox="1"/>
            <p:nvPr/>
          </p:nvSpPr>
          <p:spPr>
            <a:xfrm>
              <a:off x="1212840" y="1332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00B13C6C-6AB9-4FBC-810C-756D3429E29B}"/>
                </a:ext>
              </a:extLst>
            </p:cNvPr>
            <p:cNvSpPr txBox="1"/>
            <p:nvPr/>
          </p:nvSpPr>
          <p:spPr>
            <a:xfrm>
              <a:off x="5835011" y="28126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FE3FB46-6BB3-40B3-9C7C-E90DBC65B342}"/>
                </a:ext>
              </a:extLst>
            </p:cNvPr>
            <p:cNvSpPr txBox="1"/>
            <p:nvPr/>
          </p:nvSpPr>
          <p:spPr>
            <a:xfrm>
              <a:off x="1212840" y="378745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89CA19FF-23BF-4E93-851F-00C263D3DCDF}"/>
                </a:ext>
              </a:extLst>
            </p:cNvPr>
            <p:cNvSpPr txBox="1"/>
            <p:nvPr/>
          </p:nvSpPr>
          <p:spPr>
            <a:xfrm>
              <a:off x="5830111" y="376883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矩形 22">
            <a:extLst>
              <a:ext uri="{FF2B5EF4-FFF2-40B4-BE49-F238E27FC236}">
                <a16:creationId xmlns:a16="http://schemas.microsoft.com/office/drawing/2014/main" id="{3AAE31F8-7E3C-4BC2-9FFC-04AAF9E69303}"/>
              </a:ext>
            </a:extLst>
          </p:cNvPr>
          <p:cNvSpPr/>
          <p:nvPr/>
        </p:nvSpPr>
        <p:spPr>
          <a:xfrm>
            <a:off x="9125651" y="28225"/>
            <a:ext cx="3149979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quality control and dataset partitioning. A: Diagnosis of bad samples of dry powder; B: Diagnosis of bad samples of water-washed powder; C: Dataset partitioning of dry powder (trait: area of LVB under MSC pretreatment); D: Dataset partitioning of water-washed powder (trait: area of LVB under  MSC pretreatment)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211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>
            <a:extLst>
              <a:ext uri="{FF2B5EF4-FFF2-40B4-BE49-F238E27FC236}">
                <a16:creationId xmlns:a16="http://schemas.microsoft.com/office/drawing/2014/main" id="{222E88C3-E5B3-4BF5-85AE-2C577234BAED}"/>
              </a:ext>
            </a:extLst>
          </p:cNvPr>
          <p:cNvSpPr/>
          <p:nvPr/>
        </p:nvSpPr>
        <p:spPr>
          <a:xfrm>
            <a:off x="9626786" y="519429"/>
            <a:ext cx="2241559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s of spectra of dry powder. A</a:t>
            </a:r>
            <a:r>
              <a:rPr lang="zh-CN" altLang="en-US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a of SNV (standard normal variation) treatment; B: B: Spectra of SG (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vitzky-Golay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reatment; C: Spectra of FD (first derivative) treatment; D: Spectra of MSC (multiple scatter correction) treatment.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4A8EB47-9E02-4BE4-8ED6-98D1CCE663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735" y="589041"/>
            <a:ext cx="8217967" cy="4898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6976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5D6729E7-6345-4C15-B2E4-87839DA51AEF}"/>
              </a:ext>
            </a:extLst>
          </p:cNvPr>
          <p:cNvSpPr/>
          <p:nvPr/>
        </p:nvSpPr>
        <p:spPr>
          <a:xfrm>
            <a:off x="8750284" y="2613392"/>
            <a:ext cx="3217682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treatments of spectra of water-washed powder. A</a:t>
            </a:r>
            <a:r>
              <a:rPr lang="zh-CN" altLang="en-US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a of SNV (standard normal variation) treatment; B: Spectra of SG (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vitzky-Golay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reatment; C: Spectra of FD (first derivative) treatment; D: Spectra of MSC (multiple scatter correction) treatment.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9AD54A0-A262-416D-B8C6-A34F749F57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353" y="1142977"/>
            <a:ext cx="8389931" cy="505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6133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0</TotalTime>
  <Words>191</Words>
  <Application>Microsoft Office PowerPoint</Application>
  <PresentationFormat>宽屏</PresentationFormat>
  <Paragraphs>1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</dc:title>
  <dc:creator>12</dc:creator>
  <cp:lastModifiedBy>12</cp:lastModifiedBy>
  <cp:revision>58</cp:revision>
  <dcterms:created xsi:type="dcterms:W3CDTF">2023-02-20T09:39:47Z</dcterms:created>
  <dcterms:modified xsi:type="dcterms:W3CDTF">2023-11-20T13:23:47Z</dcterms:modified>
</cp:coreProperties>
</file>